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, schematic&#10;&#10;Description automatically generated">
            <a:extLst>
              <a:ext uri="{FF2B5EF4-FFF2-40B4-BE49-F238E27FC236}">
                <a16:creationId xmlns:a16="http://schemas.microsoft.com/office/drawing/2014/main" id="{D3B2A037-246C-69BE-C068-82418AD6EB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20002"/>
            <a:ext cx="5899127" cy="5899127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6096000"/>
            <a:ext cx="116681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1. Mean (10 replicates of a fivefold partition) within environments correlation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axis) between observed and predicted values for four models under the cross-validation scheme CV2 which mimics the incomplete field trials prediction scenario (predicting tested genotypes in observed environments);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axis depicts the number of genotypes tested at each environment. Environments with correlations below zero are connected with a blue lin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2</cp:revision>
  <dcterms:created xsi:type="dcterms:W3CDTF">2022-08-30T03:12:47Z</dcterms:created>
  <dcterms:modified xsi:type="dcterms:W3CDTF">2022-08-30T03:18:43Z</dcterms:modified>
</cp:coreProperties>
</file>